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5" r:id="rId2"/>
  </p:sldIdLst>
  <p:sldSz cx="12241213" cy="6858000"/>
  <p:notesSz cx="6858000" cy="9144000"/>
  <p:defaultTextStyle>
    <a:defPPr>
      <a:defRPr lang="zh-CN"/>
    </a:defPPr>
    <a:lvl1pPr marL="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FF66CC"/>
    <a:srgbClr val="0000FF"/>
    <a:srgbClr val="DEA900"/>
    <a:srgbClr val="B489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70" autoAdjust="0"/>
    <p:restoredTop sz="94774" autoAdjust="0"/>
  </p:normalViewPr>
  <p:slideViewPr>
    <p:cSldViewPr>
      <p:cViewPr>
        <p:scale>
          <a:sx n="96" d="100"/>
          <a:sy n="96" d="100"/>
        </p:scale>
        <p:origin x="-1560" y="-414"/>
      </p:cViewPr>
      <p:guideLst>
        <p:guide orient="horz" pos="2160"/>
        <p:guide pos="385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98A7FA-6879-4E0B-9967-F3ACD223DC6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69888" y="685800"/>
            <a:ext cx="61182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51331E-9B3F-403A-90EA-E393717398A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5057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51331E-9B3F-403A-90EA-E393717398AD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65608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8093" y="2130428"/>
            <a:ext cx="1040503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36183" y="3886200"/>
            <a:ext cx="8568849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7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74881" y="274642"/>
            <a:ext cx="2754273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12061" y="274642"/>
            <a:ext cx="8058797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6973" y="4406903"/>
            <a:ext cx="1040503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6973" y="2906713"/>
            <a:ext cx="1040503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571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3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79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2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12061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22616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0" y="1535115"/>
            <a:ext cx="5408662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2060" y="2174876"/>
            <a:ext cx="5408662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18370" y="1535115"/>
            <a:ext cx="5410786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18370" y="2174876"/>
            <a:ext cx="5410786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2065" y="273049"/>
            <a:ext cx="4027275" cy="116205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85976" y="273053"/>
            <a:ext cx="6843178" cy="5853113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12065" y="1435103"/>
            <a:ext cx="4027275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99363" y="4800603"/>
            <a:ext cx="7344728" cy="566739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99363" y="612776"/>
            <a:ext cx="7344728" cy="4114800"/>
          </a:xfrm>
        </p:spPr>
        <p:txBody>
          <a:bodyPr/>
          <a:lstStyle>
            <a:lvl1pPr marL="0" indent="0">
              <a:buNone/>
              <a:defRPr sz="3300"/>
            </a:lvl1pPr>
            <a:lvl2pPr marL="457133" indent="0">
              <a:buNone/>
              <a:defRPr sz="2800"/>
            </a:lvl2pPr>
            <a:lvl3pPr marL="914265" indent="0">
              <a:buNone/>
              <a:defRPr sz="2400"/>
            </a:lvl3pPr>
            <a:lvl4pPr marL="1371398" indent="0">
              <a:buNone/>
              <a:defRPr sz="2100"/>
            </a:lvl4pPr>
            <a:lvl5pPr marL="1828530" indent="0">
              <a:buNone/>
              <a:defRPr sz="2100"/>
            </a:lvl5pPr>
            <a:lvl6pPr marL="2285662" indent="0">
              <a:buNone/>
              <a:defRPr sz="2100"/>
            </a:lvl6pPr>
            <a:lvl7pPr marL="2742796" indent="0">
              <a:buNone/>
              <a:defRPr sz="2100"/>
            </a:lvl7pPr>
            <a:lvl8pPr marL="3199928" indent="0">
              <a:buNone/>
              <a:defRPr sz="2100"/>
            </a:lvl8pPr>
            <a:lvl9pPr marL="3657060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99363" y="5367340"/>
            <a:ext cx="7344728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12061" y="274637"/>
            <a:ext cx="11017092" cy="1143000"/>
          </a:xfrm>
          <a:prstGeom prst="rect">
            <a:avLst/>
          </a:prstGeom>
        </p:spPr>
        <p:txBody>
          <a:bodyPr vert="horz" lIns="91427" tIns="45713" rIns="91427" bIns="4571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1" y="1600204"/>
            <a:ext cx="11017092" cy="4525963"/>
          </a:xfrm>
          <a:prstGeom prst="rect">
            <a:avLst/>
          </a:prstGeom>
        </p:spPr>
        <p:txBody>
          <a:bodyPr vert="horz" lIns="91427" tIns="45713" rIns="91427" bIns="4571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12061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82416" y="6356353"/>
            <a:ext cx="3876384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72869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6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0" indent="-342850" algn="l" defTabSz="91426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41" indent="-285707" algn="l" defTabSz="914265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3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64" indent="-228566" algn="l" defTabSz="914265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96" indent="-228566" algn="l" defTabSz="914265" rtl="0" eaLnBrk="1" latinLnBrk="0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29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6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494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26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3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5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9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3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62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96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2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6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8598" y="72297"/>
            <a:ext cx="2016646" cy="478160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449" y="8881"/>
            <a:ext cx="2435040" cy="6858000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="" xmlns:a16="http://schemas.microsoft.com/office/drawing/2014/main" id="{E6EE13A0-C6E9-456F-AE18-9F263704201D}"/>
              </a:ext>
            </a:extLst>
          </p:cNvPr>
          <p:cNvSpPr/>
          <p:nvPr/>
        </p:nvSpPr>
        <p:spPr>
          <a:xfrm>
            <a:off x="4279365" y="6604059"/>
            <a:ext cx="46202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zh-CN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03" name="Picture 7" descr="F:\1.华中农业大学文章\100###999.蒺藜苜蓿-MtPHD6-权文利\PHD6 STRING\String_interactions-PHD6-confidence0.4-AP2.tsv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65" r="20714"/>
          <a:stretch/>
        </p:blipFill>
        <p:spPr bwMode="auto">
          <a:xfrm>
            <a:off x="3134006" y="672007"/>
            <a:ext cx="2828131" cy="28161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F:\1.华中农业大学文章\100###999.蒺藜苜蓿-MtPHD6-权文利\PHD6 STRING\String_interactions-drought-confidence0.4-AP2.tsv.pn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69" r="23095"/>
          <a:stretch/>
        </p:blipFill>
        <p:spPr bwMode="auto">
          <a:xfrm>
            <a:off x="3084217" y="3926383"/>
            <a:ext cx="2877920" cy="28161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4" name="矩形 103">
            <a:extLst>
              <a:ext uri="{FF2B5EF4-FFF2-40B4-BE49-F238E27FC236}">
                <a16:creationId xmlns="" xmlns:a16="http://schemas.microsoft.com/office/drawing/2014/main" id="{2F17B400-402B-41FB-BC22-76350F4F21C8}"/>
              </a:ext>
            </a:extLst>
          </p:cNvPr>
          <p:cNvSpPr/>
          <p:nvPr/>
        </p:nvSpPr>
        <p:spPr>
          <a:xfrm>
            <a:off x="3519511" y="3502036"/>
            <a:ext cx="246286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MtPHD6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vs. WT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" name="矩形 104">
            <a:extLst>
              <a:ext uri="{FF2B5EF4-FFF2-40B4-BE49-F238E27FC236}">
                <a16:creationId xmlns="" xmlns:a16="http://schemas.microsoft.com/office/drawing/2014/main" id="{86B815CD-CF7A-47D7-8F3B-4DF8B6317BBC}"/>
              </a:ext>
            </a:extLst>
          </p:cNvPr>
          <p:cNvSpPr/>
          <p:nvPr/>
        </p:nvSpPr>
        <p:spPr>
          <a:xfrm>
            <a:off x="3438846" y="97923"/>
            <a:ext cx="24885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Drought  vs. control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="" xmlns:a16="http://schemas.microsoft.com/office/drawing/2014/main" id="{605A49ED-8683-413C-B92C-83F096AC77BE}"/>
              </a:ext>
            </a:extLst>
          </p:cNvPr>
          <p:cNvSpPr txBox="1"/>
          <p:nvPr/>
        </p:nvSpPr>
        <p:spPr>
          <a:xfrm>
            <a:off x="3019588" y="81044"/>
            <a:ext cx="487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" name="TextBox 10">
            <a:extLst>
              <a:ext uri="{FF2B5EF4-FFF2-40B4-BE49-F238E27FC236}">
                <a16:creationId xmlns="" xmlns:a16="http://schemas.microsoft.com/office/drawing/2014/main" id="{023D8309-8A66-4556-804C-06053EAA00DA}"/>
              </a:ext>
            </a:extLst>
          </p:cNvPr>
          <p:cNvSpPr txBox="1"/>
          <p:nvPr/>
        </p:nvSpPr>
        <p:spPr>
          <a:xfrm>
            <a:off x="3084217" y="3742420"/>
            <a:ext cx="487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" name="TextBox 10">
            <a:extLst>
              <a:ext uri="{FF2B5EF4-FFF2-40B4-BE49-F238E27FC236}">
                <a16:creationId xmlns="" xmlns:a16="http://schemas.microsoft.com/office/drawing/2014/main" id="{6847A304-CACB-486F-8AAB-9D30620C1F27}"/>
              </a:ext>
            </a:extLst>
          </p:cNvPr>
          <p:cNvSpPr txBox="1"/>
          <p:nvPr/>
        </p:nvSpPr>
        <p:spPr>
          <a:xfrm>
            <a:off x="209336" y="42475"/>
            <a:ext cx="487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2" name="椭圆 111">
            <a:extLst>
              <a:ext uri="{FF2B5EF4-FFF2-40B4-BE49-F238E27FC236}">
                <a16:creationId xmlns="" xmlns:a16="http://schemas.microsoft.com/office/drawing/2014/main" id="{5DA3B4C4-8807-4650-A8E9-A95ED1526249}"/>
              </a:ext>
            </a:extLst>
          </p:cNvPr>
          <p:cNvSpPr/>
          <p:nvPr/>
        </p:nvSpPr>
        <p:spPr>
          <a:xfrm>
            <a:off x="4238348" y="1807303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13" name="椭圆 112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4721308" y="1688189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14" name="文本框 46">
            <a:extLst>
              <a:ext uri="{FF2B5EF4-FFF2-40B4-BE49-F238E27FC236}">
                <a16:creationId xmlns="" xmlns:a16="http://schemas.microsoft.com/office/drawing/2014/main" id="{4E0769A7-C52E-47AA-92D6-F78008B0D8FF}"/>
              </a:ext>
            </a:extLst>
          </p:cNvPr>
          <p:cNvSpPr txBox="1"/>
          <p:nvPr/>
        </p:nvSpPr>
        <p:spPr>
          <a:xfrm>
            <a:off x="4042924" y="1785660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-1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4519800" y="1665415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6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椭圆 115">
            <a:extLst>
              <a:ext uri="{FF2B5EF4-FFF2-40B4-BE49-F238E27FC236}">
                <a16:creationId xmlns="" xmlns:a16="http://schemas.microsoft.com/office/drawing/2014/main" id="{BCD4A1AB-33BB-4518-A856-4E731B42BA36}"/>
              </a:ext>
            </a:extLst>
          </p:cNvPr>
          <p:cNvSpPr/>
          <p:nvPr/>
        </p:nvSpPr>
        <p:spPr>
          <a:xfrm>
            <a:off x="4460843" y="1662683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17" name="文本框 48">
            <a:extLst>
              <a:ext uri="{FF2B5EF4-FFF2-40B4-BE49-F238E27FC236}">
                <a16:creationId xmlns="" xmlns:a16="http://schemas.microsoft.com/office/drawing/2014/main" id="{D4ECF0ED-5915-4860-984D-18BFAFB0557C}"/>
              </a:ext>
            </a:extLst>
          </p:cNvPr>
          <p:cNvSpPr txBox="1"/>
          <p:nvPr/>
        </p:nvSpPr>
        <p:spPr>
          <a:xfrm>
            <a:off x="4258110" y="1640154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11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椭圆 119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4925701" y="2005853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21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4724193" y="1983079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5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椭圆 123">
            <a:extLst>
              <a:ext uri="{FF2B5EF4-FFF2-40B4-BE49-F238E27FC236}">
                <a16:creationId xmlns="" xmlns:a16="http://schemas.microsoft.com/office/drawing/2014/main" id="{5DA3B4C4-8807-4650-A8E9-A95ED1526249}"/>
              </a:ext>
            </a:extLst>
          </p:cNvPr>
          <p:cNvSpPr/>
          <p:nvPr/>
        </p:nvSpPr>
        <p:spPr>
          <a:xfrm>
            <a:off x="4193622" y="2067775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25" name="文本框 46">
            <a:extLst>
              <a:ext uri="{FF2B5EF4-FFF2-40B4-BE49-F238E27FC236}">
                <a16:creationId xmlns="" xmlns:a16="http://schemas.microsoft.com/office/drawing/2014/main" id="{4E0769A7-C52E-47AA-92D6-F78008B0D8FF}"/>
              </a:ext>
            </a:extLst>
          </p:cNvPr>
          <p:cNvSpPr txBox="1"/>
          <p:nvPr/>
        </p:nvSpPr>
        <p:spPr>
          <a:xfrm>
            <a:off x="3983953" y="2046132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104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椭圆 125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4808222" y="2192505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27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4606714" y="2169731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2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椭圆 127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4296831" y="2234703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29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4095323" y="2211929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13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椭圆 129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4439451" y="2347983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31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4237943" y="2325209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BF2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椭圆 131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4687308" y="2291148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33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4485800" y="2268374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REB26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椭圆 153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430553" y="4740893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55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4219788" y="4710131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11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椭圆 155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777503" y="4864192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57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4566738" y="4833430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6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椭圆 157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916029" y="5201455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59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4705264" y="5170693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2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椭圆 159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856509" y="5392641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61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4645744" y="5361879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BF1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椭圆 161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708311" y="5542064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63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4497546" y="5511302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REB26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椭圆 163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420758" y="5547945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65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4209993" y="5517183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REB1A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椭圆 165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152834" y="5423604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67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3942069" y="5392842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BF2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椭圆 167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111695" y="5182973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69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3900930" y="5152211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104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椭圆 169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4139144" y="4925980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71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3928379" y="4895218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F-1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9" name="Picture 9" descr="F:\1.华中农业大学文章\100###999.蒺藜苜蓿-MtPHD6-权文利\PHD6 STRING\String_interactions-drought-confidence0.4-WRKY.tsv.pn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80" r="18653"/>
          <a:stretch/>
        </p:blipFill>
        <p:spPr bwMode="auto">
          <a:xfrm>
            <a:off x="8508055" y="3705575"/>
            <a:ext cx="2750892" cy="27416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0" name="Picture 10" descr="F:\1.华中农业大学文章\100###999.蒺藜苜蓿-MtPHD6-权文利\PHD6 STRING\String_interactions-PHD6-confidence0.4-WRKY.tsv.pn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80" r="18653"/>
          <a:stretch/>
        </p:blipFill>
        <p:spPr bwMode="auto">
          <a:xfrm>
            <a:off x="8508055" y="574973"/>
            <a:ext cx="2750892" cy="27416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9" name="椭圆 118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9585396" y="4804491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22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9374631" y="4773729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33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椭圆 122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9832404" y="4700600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34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9621639" y="4669838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40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椭圆 134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10093934" y="4889130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36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9883169" y="4858368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46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椭圆 136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9942956" y="5107150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38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9732191" y="5076388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53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椭圆 138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9736869" y="5161273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40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9526104" y="5130511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18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椭圆 140">
            <a:extLst>
              <a:ext uri="{FF2B5EF4-FFF2-40B4-BE49-F238E27FC236}">
                <a16:creationId xmlns="" xmlns:a16="http://schemas.microsoft.com/office/drawing/2014/main" id="{6A0DBF53-6067-4529-A49A-A11119CC51EA}"/>
              </a:ext>
            </a:extLst>
          </p:cNvPr>
          <p:cNvSpPr/>
          <p:nvPr/>
        </p:nvSpPr>
        <p:spPr>
          <a:xfrm>
            <a:off x="9558087" y="4988869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dirty="0">
              <a:solidFill>
                <a:srgbClr val="00B050"/>
              </a:solidFill>
            </a:endParaRPr>
          </a:p>
        </p:txBody>
      </p:sp>
      <p:sp>
        <p:nvSpPr>
          <p:cNvPr id="142" name="文本框 40">
            <a:extLst>
              <a:ext uri="{FF2B5EF4-FFF2-40B4-BE49-F238E27FC236}">
                <a16:creationId xmlns="" xmlns:a16="http://schemas.microsoft.com/office/drawing/2014/main" id="{40A6C368-B8AE-4BCC-8466-A945A522F905}"/>
              </a:ext>
            </a:extLst>
          </p:cNvPr>
          <p:cNvSpPr txBox="1"/>
          <p:nvPr/>
        </p:nvSpPr>
        <p:spPr>
          <a:xfrm>
            <a:off x="9347322" y="4958107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25</a:t>
            </a:r>
            <a:endParaRPr lang="zh-CN" altLang="en-US" sz="5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椭圆 142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9930540" y="2184867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44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9729032" y="2162093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25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椭圆 144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10081518" y="1940638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46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9880010" y="1917864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46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椭圆 146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10039983" y="1652291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48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9838475" y="1629517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33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椭圆 148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9700835" y="1590426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50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9499327" y="1567652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40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椭圆 150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9518980" y="1817055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52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9317472" y="1794281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53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椭圆 152">
            <a:extLst>
              <a:ext uri="{FF2B5EF4-FFF2-40B4-BE49-F238E27FC236}">
                <a16:creationId xmlns="" xmlns:a16="http://schemas.microsoft.com/office/drawing/2014/main" id="{738A33A7-A174-4755-BED6-FB4F32228B8B}"/>
              </a:ext>
            </a:extLst>
          </p:cNvPr>
          <p:cNvSpPr/>
          <p:nvPr/>
        </p:nvSpPr>
        <p:spPr>
          <a:xfrm>
            <a:off x="9596201" y="2102215"/>
            <a:ext cx="108000" cy="108000"/>
          </a:xfrm>
          <a:prstGeom prst="ellips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solidFill>
                <a:srgbClr val="FF0000"/>
              </a:solidFill>
            </a:endParaRPr>
          </a:p>
        </p:txBody>
      </p:sp>
      <p:sp>
        <p:nvSpPr>
          <p:cNvPr id="172" name="文本框 50">
            <a:extLst>
              <a:ext uri="{FF2B5EF4-FFF2-40B4-BE49-F238E27FC236}">
                <a16:creationId xmlns="" xmlns:a16="http://schemas.microsoft.com/office/drawing/2014/main" id="{59CB4C41-923C-403E-B682-CB1F1D7E9A8A}"/>
              </a:ext>
            </a:extLst>
          </p:cNvPr>
          <p:cNvSpPr txBox="1"/>
          <p:nvPr/>
        </p:nvSpPr>
        <p:spPr>
          <a:xfrm>
            <a:off x="9394693" y="2079441"/>
            <a:ext cx="53584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18</a:t>
            </a:r>
            <a:endParaRPr lang="zh-CN" altLang="en-US" sz="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矩形 172">
            <a:extLst>
              <a:ext uri="{FF2B5EF4-FFF2-40B4-BE49-F238E27FC236}">
                <a16:creationId xmlns="" xmlns:a16="http://schemas.microsoft.com/office/drawing/2014/main" id="{2F17B400-402B-41FB-BC22-76350F4F21C8}"/>
              </a:ext>
            </a:extLst>
          </p:cNvPr>
          <p:cNvSpPr/>
          <p:nvPr/>
        </p:nvSpPr>
        <p:spPr>
          <a:xfrm>
            <a:off x="8773523" y="3521001"/>
            <a:ext cx="246286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MtPHD6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vs. WT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" name="矩形 173">
            <a:extLst>
              <a:ext uri="{FF2B5EF4-FFF2-40B4-BE49-F238E27FC236}">
                <a16:creationId xmlns="" xmlns:a16="http://schemas.microsoft.com/office/drawing/2014/main" id="{86B815CD-CF7A-47D7-8F3B-4DF8B6317BBC}"/>
              </a:ext>
            </a:extLst>
          </p:cNvPr>
          <p:cNvSpPr/>
          <p:nvPr/>
        </p:nvSpPr>
        <p:spPr>
          <a:xfrm>
            <a:off x="8692858" y="116888"/>
            <a:ext cx="24885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Drought  vs. control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="" xmlns:a16="http://schemas.microsoft.com/office/drawing/2014/main" id="{605A49ED-8683-413C-B92C-83F096AC77BE}"/>
              </a:ext>
            </a:extLst>
          </p:cNvPr>
          <p:cNvSpPr txBox="1"/>
          <p:nvPr/>
        </p:nvSpPr>
        <p:spPr>
          <a:xfrm>
            <a:off x="8273600" y="100009"/>
            <a:ext cx="487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dirty="0" smtClean="0">
                <a:latin typeface="Times New Roman" pitchFamily="18" charset="0"/>
                <a:cs typeface="Times New Roman" pitchFamily="18" charset="0"/>
              </a:rPr>
              <a:t>e</a:t>
            </a:r>
            <a:endParaRPr lang="zh-CN" alt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6" name="TextBox 10">
            <a:extLst>
              <a:ext uri="{FF2B5EF4-FFF2-40B4-BE49-F238E27FC236}">
                <a16:creationId xmlns="" xmlns:a16="http://schemas.microsoft.com/office/drawing/2014/main" id="{023D8309-8A66-4556-804C-06053EAA00DA}"/>
              </a:ext>
            </a:extLst>
          </p:cNvPr>
          <p:cNvSpPr txBox="1"/>
          <p:nvPr/>
        </p:nvSpPr>
        <p:spPr>
          <a:xfrm>
            <a:off x="8379135" y="3742420"/>
            <a:ext cx="487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dirty="0" smtClean="0">
                <a:latin typeface="Times New Roman" pitchFamily="18" charset="0"/>
                <a:cs typeface="Times New Roman" pitchFamily="18" charset="0"/>
              </a:rPr>
              <a:t>f</a:t>
            </a:r>
            <a:endParaRPr lang="zh-CN" alt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7" name="TextBox 10">
            <a:extLst>
              <a:ext uri="{FF2B5EF4-FFF2-40B4-BE49-F238E27FC236}">
                <a16:creationId xmlns="" xmlns:a16="http://schemas.microsoft.com/office/drawing/2014/main" id="{6847A304-CACB-486F-8AAB-9D30620C1F27}"/>
              </a:ext>
            </a:extLst>
          </p:cNvPr>
          <p:cNvSpPr txBox="1"/>
          <p:nvPr/>
        </p:nvSpPr>
        <p:spPr>
          <a:xfrm>
            <a:off x="6081804" y="61440"/>
            <a:ext cx="487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zh-CN" alt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9" name="TextBox 10">
            <a:extLst>
              <a:ext uri="{FF2B5EF4-FFF2-40B4-BE49-F238E27FC236}">
                <a16:creationId xmlns:a16="http://schemas.microsoft.com/office/drawing/2014/main" xmlns="" id="{6847A304-CACB-486F-8AAB-9D30620C1F27}"/>
              </a:ext>
            </a:extLst>
          </p:cNvPr>
          <p:cNvSpPr txBox="1"/>
          <p:nvPr/>
        </p:nvSpPr>
        <p:spPr>
          <a:xfrm>
            <a:off x="76195" y="1543601"/>
            <a:ext cx="1050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luster 1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TextBox 10">
            <a:extLst>
              <a:ext uri="{FF2B5EF4-FFF2-40B4-BE49-F238E27FC236}">
                <a16:creationId xmlns:a16="http://schemas.microsoft.com/office/drawing/2014/main" xmlns="" id="{6847A304-CACB-486F-8AAB-9D30620C1F27}"/>
              </a:ext>
            </a:extLst>
          </p:cNvPr>
          <p:cNvSpPr txBox="1"/>
          <p:nvPr/>
        </p:nvSpPr>
        <p:spPr>
          <a:xfrm>
            <a:off x="108449" y="2524130"/>
            <a:ext cx="1050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luster 2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TextBox 10">
            <a:extLst>
              <a:ext uri="{FF2B5EF4-FFF2-40B4-BE49-F238E27FC236}">
                <a16:creationId xmlns:a16="http://schemas.microsoft.com/office/drawing/2014/main" xmlns="" id="{6847A304-CACB-486F-8AAB-9D30620C1F27}"/>
              </a:ext>
            </a:extLst>
          </p:cNvPr>
          <p:cNvSpPr txBox="1"/>
          <p:nvPr/>
        </p:nvSpPr>
        <p:spPr>
          <a:xfrm>
            <a:off x="143942" y="3220671"/>
            <a:ext cx="1050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luster 3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TextBox 10">
            <a:extLst>
              <a:ext uri="{FF2B5EF4-FFF2-40B4-BE49-F238E27FC236}">
                <a16:creationId xmlns:a16="http://schemas.microsoft.com/office/drawing/2014/main" xmlns="" id="{6847A304-CACB-486F-8AAB-9D30620C1F27}"/>
              </a:ext>
            </a:extLst>
          </p:cNvPr>
          <p:cNvSpPr txBox="1"/>
          <p:nvPr/>
        </p:nvSpPr>
        <p:spPr>
          <a:xfrm>
            <a:off x="143942" y="4388347"/>
            <a:ext cx="1050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luster 4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TextBox 10">
            <a:extLst>
              <a:ext uri="{FF2B5EF4-FFF2-40B4-BE49-F238E27FC236}">
                <a16:creationId xmlns:a16="http://schemas.microsoft.com/office/drawing/2014/main" xmlns="" id="{6847A304-CACB-486F-8AAB-9D30620C1F27}"/>
              </a:ext>
            </a:extLst>
          </p:cNvPr>
          <p:cNvSpPr txBox="1"/>
          <p:nvPr/>
        </p:nvSpPr>
        <p:spPr>
          <a:xfrm>
            <a:off x="108449" y="6262536"/>
            <a:ext cx="1050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luster 5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4" name="图片 83" descr="受转基因影响_colorbar.png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189639" y="374922"/>
            <a:ext cx="499922" cy="847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5029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70</TotalTime>
  <Words>65</Words>
  <Application>Microsoft Office PowerPoint</Application>
  <PresentationFormat>Custom</PresentationFormat>
  <Paragraphs>4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D6-EX AT. Drought stress</dc:title>
  <dc:creator>Wenli Quan</dc:creator>
  <cp:lastModifiedBy>Colonia, Norbeliza</cp:lastModifiedBy>
  <cp:revision>1468</cp:revision>
  <dcterms:created xsi:type="dcterms:W3CDTF">2018-01-22T02:45:40Z</dcterms:created>
  <dcterms:modified xsi:type="dcterms:W3CDTF">2019-12-04T02:06:05Z</dcterms:modified>
</cp:coreProperties>
</file>